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1452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1334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6338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585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7957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1485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1014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6615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056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5170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39255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7197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673F81-1D19-4F84-BEB8-39E12C254098}" type="datetimeFigureOut">
              <a:rPr lang="fr-FR" smtClean="0"/>
              <a:t>10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20E8AB-92A5-4498-97B8-10900D9DF5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9784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44" r="50866"/>
          <a:stretch/>
        </p:blipFill>
        <p:spPr bwMode="auto">
          <a:xfrm>
            <a:off x="467544" y="692696"/>
            <a:ext cx="2880320" cy="38463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ZoneTexte 7"/>
          <p:cNvSpPr txBox="1"/>
          <p:nvPr/>
        </p:nvSpPr>
        <p:spPr>
          <a:xfrm>
            <a:off x="305480" y="30495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4544738" y="31094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B</a:t>
            </a:r>
            <a:endParaRPr lang="fr-FR" b="1" dirty="0"/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695" b="-5809"/>
          <a:stretch/>
        </p:blipFill>
        <p:spPr bwMode="auto">
          <a:xfrm>
            <a:off x="4265920" y="692696"/>
            <a:ext cx="2932885" cy="4069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305480" y="4774908"/>
            <a:ext cx="823608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1: </a:t>
            </a:r>
            <a:r>
              <a:rPr lang="en-US" sz="1200" dirty="0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ample of deconvolution of LH pulse for (A) a patient from Persistent Amenorrhea Recovered Anorexia Nervosa (PA-</a:t>
            </a:r>
            <a:r>
              <a:rPr lang="en-US" sz="1200" dirty="0" err="1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Rec</a:t>
            </a:r>
            <a:r>
              <a:rPr lang="en-US" sz="1200" dirty="0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group and (B) a patient from Recovered Menses Recovered Anorexia Nervosa (RM-</a:t>
            </a:r>
            <a:r>
              <a:rPr lang="en-US" sz="1200" dirty="0" err="1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Rec</a:t>
            </a:r>
            <a:r>
              <a:rPr lang="en-US" sz="1200" dirty="0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group at visit 1. The upper graphs present the absolute LH values throughout the LH </a:t>
            </a:r>
            <a:r>
              <a:rPr lang="en-US" sz="1200" dirty="0" err="1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ulsatility</a:t>
            </a:r>
            <a:r>
              <a:rPr lang="en-US" sz="1200" dirty="0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4-hour test while the lower graphs are issued from the deconvolution analysis. Patient (A) present with no pulses while pulses were detected in patient (B).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190001214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90</Words>
  <Application>Microsoft Office PowerPoint</Application>
  <PresentationFormat>Affichage à l'écran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G</dc:creator>
  <cp:lastModifiedBy>Galusca Bogdan</cp:lastModifiedBy>
  <cp:revision>7</cp:revision>
  <dcterms:created xsi:type="dcterms:W3CDTF">2022-11-11T10:52:10Z</dcterms:created>
  <dcterms:modified xsi:type="dcterms:W3CDTF">2023-09-10T09:23:27Z</dcterms:modified>
</cp:coreProperties>
</file>